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862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  <p:sldId id="281" r:id="rId2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756"/>
    <p:restoredTop sz="94659"/>
  </p:normalViewPr>
  <p:slideViewPr>
    <p:cSldViewPr snapToGrid="0" snapToObjects="1">
      <p:cViewPr varScale="1">
        <p:scale>
          <a:sx n="89" d="100"/>
          <a:sy n="89" d="100"/>
        </p:scale>
        <p:origin x="250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83509-4288-5149-97DD-F8D9D67E0051}" type="datetimeFigureOut">
              <a:rPr lang="en-US" smtClean="0"/>
              <a:t>12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C8B35-6B85-EE47-9ADE-2805B193AB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0520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83509-4288-5149-97DD-F8D9D67E0051}" type="datetimeFigureOut">
              <a:rPr lang="en-US" smtClean="0"/>
              <a:t>12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C8B35-6B85-EE47-9ADE-2805B193AB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06506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83509-4288-5149-97DD-F8D9D67E0051}" type="datetimeFigureOut">
              <a:rPr lang="en-US" smtClean="0"/>
              <a:t>12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C8B35-6B85-EE47-9ADE-2805B193AB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0653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83509-4288-5149-97DD-F8D9D67E0051}" type="datetimeFigureOut">
              <a:rPr lang="en-US" smtClean="0"/>
              <a:t>12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C8B35-6B85-EE47-9ADE-2805B193AB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8179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83509-4288-5149-97DD-F8D9D67E0051}" type="datetimeFigureOut">
              <a:rPr lang="en-US" smtClean="0"/>
              <a:t>12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C8B35-6B85-EE47-9ADE-2805B193AB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60395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83509-4288-5149-97DD-F8D9D67E0051}" type="datetimeFigureOut">
              <a:rPr lang="en-US" smtClean="0"/>
              <a:t>12/2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C8B35-6B85-EE47-9ADE-2805B193AB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0197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83509-4288-5149-97DD-F8D9D67E0051}" type="datetimeFigureOut">
              <a:rPr lang="en-US" smtClean="0"/>
              <a:t>12/29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C8B35-6B85-EE47-9ADE-2805B193AB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91440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83509-4288-5149-97DD-F8D9D67E0051}" type="datetimeFigureOut">
              <a:rPr lang="en-US" smtClean="0"/>
              <a:t>12/29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C8B35-6B85-EE47-9ADE-2805B193AB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9876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83509-4288-5149-97DD-F8D9D67E0051}" type="datetimeFigureOut">
              <a:rPr lang="en-US" smtClean="0"/>
              <a:t>12/29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C8B35-6B85-EE47-9ADE-2805B193AB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4045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83509-4288-5149-97DD-F8D9D67E0051}" type="datetimeFigureOut">
              <a:rPr lang="en-US" smtClean="0"/>
              <a:t>12/2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C8B35-6B85-EE47-9ADE-2805B193AB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717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83509-4288-5149-97DD-F8D9D67E0051}" type="datetimeFigureOut">
              <a:rPr lang="en-US" smtClean="0"/>
              <a:t>12/2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C8B35-6B85-EE47-9ADE-2805B193AB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1549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A83509-4288-5149-97DD-F8D9D67E0051}" type="datetimeFigureOut">
              <a:rPr lang="en-US" smtClean="0"/>
              <a:t>12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1C8B35-6B85-EE47-9ADE-2805B193AB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9668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63" r:id="rId1"/>
    <p:sldLayoutId id="2147483864" r:id="rId2"/>
    <p:sldLayoutId id="2147483865" r:id="rId3"/>
    <p:sldLayoutId id="2147483866" r:id="rId4"/>
    <p:sldLayoutId id="2147483867" r:id="rId5"/>
    <p:sldLayoutId id="2147483868" r:id="rId6"/>
    <p:sldLayoutId id="2147483869" r:id="rId7"/>
    <p:sldLayoutId id="2147483870" r:id="rId8"/>
    <p:sldLayoutId id="2147483871" r:id="rId9"/>
    <p:sldLayoutId id="2147483872" r:id="rId10"/>
    <p:sldLayoutId id="214748387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/>
    </p:ext>
  </p:extLst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6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6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6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6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6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6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6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6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35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3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6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43.pn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46.png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6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png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6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png"/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52.png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Healthy Pregnancy Study Screen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2617407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onsent Flow 8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7080" y="1589314"/>
            <a:ext cx="2792506" cy="5005614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06428" y="1589314"/>
            <a:ext cx="2767458" cy="50308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704751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onsent Flow 9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4876" y="1513113"/>
            <a:ext cx="2850737" cy="5050971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10538" y="1513113"/>
            <a:ext cx="2850737" cy="50509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315938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onsent Flow 10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9765" y="1419226"/>
            <a:ext cx="2771721" cy="509111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22094" y="1419226"/>
            <a:ext cx="2939317" cy="52530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949332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onsent Flow 11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2053" y="1462088"/>
            <a:ext cx="2876145" cy="516731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91675" y="1462088"/>
            <a:ext cx="3010999" cy="53070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937772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onsent Flow 12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0986" y="1462088"/>
            <a:ext cx="2837164" cy="511651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74631" y="1525588"/>
            <a:ext cx="2972493" cy="53324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408491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onsent Flow 13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8760" y="1362076"/>
            <a:ext cx="2840801" cy="510381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12817" y="1362076"/>
            <a:ext cx="2762110" cy="47935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6631734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onsent Flow 14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3100" y="1449711"/>
            <a:ext cx="2833687" cy="506221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0623" y="1482725"/>
            <a:ext cx="2848964" cy="5029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702982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omprehension Test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57337" y="1543104"/>
            <a:ext cx="2879725" cy="521329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36723" y="1543104"/>
            <a:ext cx="2953302" cy="52005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872074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Test Cont.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5961" y="1419225"/>
            <a:ext cx="2765663" cy="507841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4098" y="1276350"/>
            <a:ext cx="3079913" cy="543877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54254" y="1156336"/>
            <a:ext cx="3161496" cy="55587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097643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ompletion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07099" y="1397000"/>
            <a:ext cx="2879575" cy="516572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1650" y="1397000"/>
            <a:ext cx="2827710" cy="5168529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03042" y="1397000"/>
            <a:ext cx="2750758" cy="49845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49753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/>
          <p:cNvSpPr>
            <a:spLocks noGrp="1"/>
          </p:cNvSpPr>
          <p:nvPr>
            <p:ph type="title"/>
          </p:nvPr>
        </p:nvSpPr>
        <p:spPr>
          <a:xfrm>
            <a:off x="1484311" y="359229"/>
            <a:ext cx="10018713" cy="696686"/>
          </a:xfrm>
        </p:spPr>
        <p:txBody>
          <a:bodyPr>
            <a:normAutofit/>
          </a:bodyPr>
          <a:lstStyle/>
          <a:p>
            <a:r>
              <a:rPr lang="en-US" dirty="0" smtClean="0"/>
              <a:t>Onboarding &amp; Eligibility</a:t>
            </a:r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8297" y="1641702"/>
            <a:ext cx="2692784" cy="4822371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94259" y="1641702"/>
            <a:ext cx="2658797" cy="48437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561800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onsent Full Review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4389" y="1371600"/>
            <a:ext cx="2960448" cy="524986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71099" y="1371600"/>
            <a:ext cx="3138037" cy="5461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73403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Signature ++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4743" y="1504951"/>
            <a:ext cx="2885781" cy="512921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8286" y="1374775"/>
            <a:ext cx="3158588" cy="548322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74636" y="1027906"/>
            <a:ext cx="3204207" cy="55546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006454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Registration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0841" y="1462088"/>
            <a:ext cx="2896833" cy="509111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3674" y="1293813"/>
            <a:ext cx="3090676" cy="525938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44135" y="1462088"/>
            <a:ext cx="2609665" cy="46443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7671125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Registration Thanks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9828" y="1443038"/>
            <a:ext cx="2985259" cy="52816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8618805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Learn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4375" y="1514475"/>
            <a:ext cx="2793287" cy="497205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95877" y="1514475"/>
            <a:ext cx="2822211" cy="49388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2670914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Learn Cont. 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5857" y="1690688"/>
            <a:ext cx="2448917" cy="436086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9409" y="1690688"/>
            <a:ext cx="2644877" cy="460692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08921" y="1719262"/>
            <a:ext cx="2594994" cy="45497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4243465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Learn Final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0834" y="1433513"/>
            <a:ext cx="2906715" cy="51419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70524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4311" y="685800"/>
            <a:ext cx="10018713" cy="653143"/>
          </a:xfrm>
        </p:spPr>
        <p:txBody>
          <a:bodyPr>
            <a:normAutofit fontScale="90000"/>
          </a:bodyPr>
          <a:lstStyle/>
          <a:p>
            <a:r>
              <a:rPr lang="en-US" dirty="0" smtClean="0"/>
              <a:t>Consent Flow 1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2979" y="1630144"/>
            <a:ext cx="2620845" cy="469174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34778" y="1469571"/>
            <a:ext cx="2828965" cy="5012888"/>
          </a:xfrm>
          <a:prstGeom prst="rect">
            <a:avLst/>
          </a:prstGeom>
        </p:spPr>
      </p:pic>
      <p:cxnSp>
        <p:nvCxnSpPr>
          <p:cNvPr id="6" name="Straight Arrow Connector 5"/>
          <p:cNvCxnSpPr/>
          <p:nvPr/>
        </p:nvCxnSpPr>
        <p:spPr>
          <a:xfrm flipV="1">
            <a:off x="4169229" y="3287487"/>
            <a:ext cx="2144485" cy="99059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22763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9343" y="147411"/>
            <a:ext cx="10515600" cy="1325563"/>
          </a:xfrm>
        </p:spPr>
        <p:txBody>
          <a:bodyPr/>
          <a:lstStyle/>
          <a:p>
            <a:r>
              <a:rPr lang="en-US" dirty="0" smtClean="0"/>
              <a:t>Consent Flow 2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3572" y="1296593"/>
            <a:ext cx="2896789" cy="5163433"/>
          </a:xfrm>
          <a:prstGeom prst="rect">
            <a:avLst/>
          </a:prstGeom>
        </p:spPr>
      </p:pic>
      <p:cxnSp>
        <p:nvCxnSpPr>
          <p:cNvPr id="6" name="Straight Arrow Connector 5"/>
          <p:cNvCxnSpPr/>
          <p:nvPr/>
        </p:nvCxnSpPr>
        <p:spPr>
          <a:xfrm flipV="1">
            <a:off x="4746171" y="4136571"/>
            <a:ext cx="2645229" cy="31568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91400" y="1110305"/>
            <a:ext cx="3088183" cy="55360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72438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onsent Flow 3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9799" y="1567837"/>
            <a:ext cx="2901043" cy="514320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22724" y="1567837"/>
            <a:ext cx="2867589" cy="51377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73768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71600" y="685800"/>
            <a:ext cx="9601200" cy="881743"/>
          </a:xfrm>
        </p:spPr>
        <p:txBody>
          <a:bodyPr/>
          <a:lstStyle/>
          <a:p>
            <a:r>
              <a:rPr lang="en-US" dirty="0" smtClean="0"/>
              <a:t>Consent Flow 4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7903" y="1687284"/>
            <a:ext cx="2646611" cy="480785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78694" y="1687284"/>
            <a:ext cx="2786219" cy="49511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54154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onsent flow 5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3049" y="1611086"/>
            <a:ext cx="2844594" cy="504008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9358" y="1626583"/>
            <a:ext cx="2807299" cy="50245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589579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onsent flow 6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3161" y="1654629"/>
            <a:ext cx="2757494" cy="490945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38198" y="1556657"/>
            <a:ext cx="2867059" cy="51045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66806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0">
              <a:schemeClr val="accent3">
                <a:lumMod val="5000"/>
                <a:lumOff val="95000"/>
              </a:schemeClr>
            </a:gs>
            <a:gs pos="74000">
              <a:schemeClr val="accent3">
                <a:lumMod val="45000"/>
                <a:lumOff val="55000"/>
              </a:schemeClr>
            </a:gs>
            <a:gs pos="83000">
              <a:schemeClr val="accent3">
                <a:lumMod val="45000"/>
                <a:lumOff val="55000"/>
              </a:schemeClr>
            </a:gs>
            <a:gs pos="100000">
              <a:schemeClr val="accent3">
                <a:lumMod val="30000"/>
                <a:lumOff val="70000"/>
              </a:schemeClr>
            </a:gs>
          </a:gsLst>
          <a:lin ang="5400000" scaled="1"/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60714" y="348343"/>
            <a:ext cx="9601200" cy="838200"/>
          </a:xfrm>
        </p:spPr>
        <p:txBody>
          <a:bodyPr/>
          <a:lstStyle/>
          <a:p>
            <a:r>
              <a:rPr lang="en-US" dirty="0" smtClean="0"/>
              <a:t>Consent Flow 7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8263" y="1665514"/>
            <a:ext cx="2776566" cy="4954814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10392" y="1665513"/>
            <a:ext cx="2838407" cy="50195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78920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5</TotalTime>
  <Words>69</Words>
  <Application>Microsoft Office PowerPoint</Application>
  <PresentationFormat>Widescreen</PresentationFormat>
  <Paragraphs>26</Paragraphs>
  <Slides>2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6</vt:i4>
      </vt:variant>
    </vt:vector>
  </HeadingPairs>
  <TitlesOfParts>
    <vt:vector size="30" baseType="lpstr">
      <vt:lpstr>Arial</vt:lpstr>
      <vt:lpstr>Calibri</vt:lpstr>
      <vt:lpstr>Calibri Light</vt:lpstr>
      <vt:lpstr>Office Theme</vt:lpstr>
      <vt:lpstr>Healthy Pregnancy Study Screens</vt:lpstr>
      <vt:lpstr>Onboarding &amp; Eligibility</vt:lpstr>
      <vt:lpstr>Consent Flow 1</vt:lpstr>
      <vt:lpstr>Consent Flow 2</vt:lpstr>
      <vt:lpstr>Consent Flow 3</vt:lpstr>
      <vt:lpstr>Consent Flow 4</vt:lpstr>
      <vt:lpstr>Consent flow 5</vt:lpstr>
      <vt:lpstr>Consent flow 6</vt:lpstr>
      <vt:lpstr>Consent Flow 7</vt:lpstr>
      <vt:lpstr>Consent Flow 8</vt:lpstr>
      <vt:lpstr>Consent Flow 9</vt:lpstr>
      <vt:lpstr>Consent Flow 10</vt:lpstr>
      <vt:lpstr>Consent Flow 11</vt:lpstr>
      <vt:lpstr>Consent Flow 12</vt:lpstr>
      <vt:lpstr>Consent Flow 13</vt:lpstr>
      <vt:lpstr>Consent Flow 14</vt:lpstr>
      <vt:lpstr>Comprehension Test</vt:lpstr>
      <vt:lpstr>Test Cont.</vt:lpstr>
      <vt:lpstr>Completion</vt:lpstr>
      <vt:lpstr>Consent Full Review</vt:lpstr>
      <vt:lpstr>Signature ++</vt:lpstr>
      <vt:lpstr>Registration</vt:lpstr>
      <vt:lpstr>Registration Thanks</vt:lpstr>
      <vt:lpstr>Learn</vt:lpstr>
      <vt:lpstr>Learn Cont. </vt:lpstr>
      <vt:lpstr>Learn Final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ealthy Pregnancy Study Screens</dc:title>
  <dc:creator>Microsoft Office User</dc:creator>
  <cp:lastModifiedBy>Ebner, Gail</cp:lastModifiedBy>
  <cp:revision>8</cp:revision>
  <dcterms:created xsi:type="dcterms:W3CDTF">2016-12-23T17:19:36Z</dcterms:created>
  <dcterms:modified xsi:type="dcterms:W3CDTF">2016-12-29T18:22:50Z</dcterms:modified>
</cp:coreProperties>
</file>